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17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25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720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927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437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137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098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561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586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45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019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291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00563-C585-4CFA-9964-F5FD315C8942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F1F5C-2C1A-4CFB-A01E-982C4C36B8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766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0631141-BD3E-4E92-A78C-CBA571CF20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3314" y="578527"/>
            <a:ext cx="4121253" cy="512108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99C1D3D-D135-4885-A403-F16CAAD7E80F}"/>
              </a:ext>
            </a:extLst>
          </p:cNvPr>
          <p:cNvSpPr/>
          <p:nvPr/>
        </p:nvSpPr>
        <p:spPr>
          <a:xfrm>
            <a:off x="207471" y="5565338"/>
            <a:ext cx="884599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(A) Western blot analysis of NF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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B nuclear signaling by Mn dose (0, 10, 100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M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for 5h) and subsequent nuclear translocation block by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mitoQ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a mitochondrial antioxidant, provides experimental validation of mitochondrial-cellular network  systems [MCS] showing Mn dependent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mtOx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induced pro-inflammatory NF-kB nuclear translocation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5788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6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rnandes, Jolyn   (HSC)</dc:creator>
  <cp:lastModifiedBy>MDPI</cp:lastModifiedBy>
  <cp:revision>7</cp:revision>
  <dcterms:created xsi:type="dcterms:W3CDTF">2021-03-10T18:35:10Z</dcterms:created>
  <dcterms:modified xsi:type="dcterms:W3CDTF">2023-03-25T10:21:53Z</dcterms:modified>
</cp:coreProperties>
</file>